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12192000" cy="216741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52" userDrawn="1">
          <p15:clr>
            <a:srgbClr val="A4A3A4"/>
          </p15:clr>
        </p15:guide>
        <p15:guide id="2" pos="38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61"/>
    <p:restoredTop sz="96405"/>
  </p:normalViewPr>
  <p:slideViewPr>
    <p:cSldViewPr snapToGrid="0" showGuides="1">
      <p:cViewPr>
        <p:scale>
          <a:sx n="60" d="100"/>
          <a:sy n="60" d="100"/>
        </p:scale>
        <p:origin x="3248" y="144"/>
      </p:cViewPr>
      <p:guideLst>
        <p:guide orient="horz" pos="5352"/>
        <p:guide pos="38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berardi\Desktop\Results\Morphology%20WT,%202%20rep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berardi\AppData\Roaming\Microsoft\Excel\Morphology%20WT,%202%20reps%20(version%201).xlsb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940719278881532"/>
          <c:y val="6.0185185185185182E-2"/>
          <c:w val="0.55631576526857984"/>
          <c:h val="0.8027102803738317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B58-0842-91ED-D511A3966962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B58-0842-91ED-D511A3966962}"/>
              </c:ext>
            </c:extLst>
          </c:dPt>
          <c:errBars>
            <c:errBarType val="both"/>
            <c:errValType val="cust"/>
            <c:noEndCap val="0"/>
            <c:plus>
              <c:numRef>
                <c:f>(Sheet1!$O$24,Sheet1!$U$24)</c:f>
                <c:numCache>
                  <c:formatCode>General</c:formatCode>
                  <c:ptCount val="2"/>
                  <c:pt idx="0">
                    <c:v>0.7144371522005627</c:v>
                  </c:pt>
                  <c:pt idx="1">
                    <c:v>0.52062809289464118</c:v>
                  </c:pt>
                </c:numCache>
              </c:numRef>
            </c:plus>
            <c:minus>
              <c:numRef>
                <c:f>(Sheet1!$O$24,Sheet1!$U$24)</c:f>
                <c:numCache>
                  <c:formatCode>General</c:formatCode>
                  <c:ptCount val="2"/>
                  <c:pt idx="0">
                    <c:v>0.7144371522005627</c:v>
                  </c:pt>
                  <c:pt idx="1">
                    <c:v>0.520628092894641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M$1,Sheet1!$S$1)</c:f>
              <c:strCache>
                <c:ptCount val="2"/>
                <c:pt idx="0">
                  <c:v>7th leaf</c:v>
                </c:pt>
                <c:pt idx="1">
                  <c:v>9th leaf</c:v>
                </c:pt>
              </c:strCache>
            </c:strRef>
          </c:cat>
          <c:val>
            <c:numRef>
              <c:f>(Sheet1!$O$22,Sheet1!$U$22)</c:f>
              <c:numCache>
                <c:formatCode>General</c:formatCode>
                <c:ptCount val="2"/>
                <c:pt idx="0">
                  <c:v>17.885999999999999</c:v>
                </c:pt>
                <c:pt idx="1">
                  <c:v>15.991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B58-0842-91ED-D511A3966962}"/>
            </c:ext>
          </c:extLst>
        </c:ser>
        <c:ser>
          <c:idx val="1"/>
          <c:order val="1"/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O$25,Sheet1!$U$25)</c:f>
                <c:numCache>
                  <c:formatCode>General</c:formatCode>
                  <c:ptCount val="2"/>
                  <c:pt idx="0">
                    <c:v>0.62305706890389367</c:v>
                  </c:pt>
                  <c:pt idx="1">
                    <c:v>0.72464926382047878</c:v>
                  </c:pt>
                </c:numCache>
              </c:numRef>
            </c:plus>
            <c:minus>
              <c:numRef>
                <c:f>(Sheet1!$O$25,Sheet1!$U$25)</c:f>
                <c:numCache>
                  <c:formatCode>General</c:formatCode>
                  <c:ptCount val="2"/>
                  <c:pt idx="0">
                    <c:v>0.62305706890389367</c:v>
                  </c:pt>
                  <c:pt idx="1">
                    <c:v>0.724649263820478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M$1,Sheet1!$S$1)</c:f>
              <c:strCache>
                <c:ptCount val="2"/>
                <c:pt idx="0">
                  <c:v>7th leaf</c:v>
                </c:pt>
                <c:pt idx="1">
                  <c:v>9th leaf</c:v>
                </c:pt>
              </c:strCache>
            </c:strRef>
          </c:cat>
          <c:val>
            <c:numRef>
              <c:f>(Sheet1!$O$23,Sheet1!$U$23)</c:f>
              <c:numCache>
                <c:formatCode>General</c:formatCode>
                <c:ptCount val="2"/>
                <c:pt idx="0">
                  <c:v>22.502999999999997</c:v>
                </c:pt>
                <c:pt idx="1">
                  <c:v>20.750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AB58-0842-91ED-D511A3966962}"/>
            </c:ext>
          </c:extLst>
        </c:ser>
        <c:ser>
          <c:idx val="2"/>
          <c:order val="2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AA$25,Sheet1!$AA$26)</c:f>
                <c:numCache>
                  <c:formatCode>General</c:formatCode>
                  <c:ptCount val="2"/>
                  <c:pt idx="0">
                    <c:v>0.92407196689434912</c:v>
                  </c:pt>
                  <c:pt idx="1">
                    <c:v>0.83105287971879493</c:v>
                  </c:pt>
                </c:numCache>
              </c:numRef>
            </c:plus>
            <c:minus>
              <c:numRef>
                <c:f>(Sheet1!$AA$25,Sheet1!$AA$26)</c:f>
                <c:numCache>
                  <c:formatCode>General</c:formatCode>
                  <c:ptCount val="2"/>
                  <c:pt idx="0">
                    <c:v>0.92407196689434912</c:v>
                  </c:pt>
                  <c:pt idx="1">
                    <c:v>0.831052879718794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M$1,Sheet1!$S$1)</c:f>
              <c:strCache>
                <c:ptCount val="2"/>
                <c:pt idx="0">
                  <c:v>7th leaf</c:v>
                </c:pt>
                <c:pt idx="1">
                  <c:v>9th leaf</c:v>
                </c:pt>
              </c:strCache>
            </c:strRef>
          </c:cat>
          <c:val>
            <c:numRef>
              <c:f>(Sheet1!$AA$23,Sheet1!$AA$24)</c:f>
              <c:numCache>
                <c:formatCode>General</c:formatCode>
                <c:ptCount val="2"/>
                <c:pt idx="0">
                  <c:v>21.737000000000002</c:v>
                </c:pt>
                <c:pt idx="1">
                  <c:v>21.05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B58-0842-91ED-D511A39669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80074240"/>
        <c:axId val="580074784"/>
      </c:barChart>
      <c:catAx>
        <c:axId val="5800742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t" anchorCtr="0"/>
          <a:lstStyle/>
          <a:p>
            <a:pPr>
              <a:defRPr sz="2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0074784"/>
        <c:crosses val="autoZero"/>
        <c:auto val="1"/>
        <c:lblAlgn val="ctr"/>
        <c:lblOffset val="100"/>
        <c:noMultiLvlLbl val="0"/>
      </c:catAx>
      <c:valAx>
        <c:axId val="5800747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dirty="0">
                    <a:solidFill>
                      <a:schemeClr val="tx1"/>
                    </a:solidFill>
                  </a:rPr>
                  <a:t>Petiole (m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00742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940719278881532"/>
          <c:y val="6.0185185185185182E-2"/>
          <c:w val="0.5816254292371843"/>
          <c:h val="0.799713018030774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P$24,Sheet1!$V$24)</c:f>
                <c:numCache>
                  <c:formatCode>General</c:formatCode>
                  <c:ptCount val="2"/>
                  <c:pt idx="0">
                    <c:v>0.91341994723128583</c:v>
                  </c:pt>
                  <c:pt idx="1">
                    <c:v>1.0556598778857622</c:v>
                  </c:pt>
                </c:numCache>
              </c:numRef>
            </c:plus>
            <c:minus>
              <c:numRef>
                <c:f>(Sheet1!$P$24,Sheet1!$V$24)</c:f>
                <c:numCache>
                  <c:formatCode>General</c:formatCode>
                  <c:ptCount val="2"/>
                  <c:pt idx="0">
                    <c:v>0.91341994723128583</c:v>
                  </c:pt>
                  <c:pt idx="1">
                    <c:v>1.05565987788576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M$1,Sheet1!$S$1)</c:f>
              <c:strCache>
                <c:ptCount val="2"/>
                <c:pt idx="0">
                  <c:v>7th leaf</c:v>
                </c:pt>
                <c:pt idx="1">
                  <c:v>9th leaf</c:v>
                </c:pt>
              </c:strCache>
            </c:strRef>
          </c:cat>
          <c:val>
            <c:numRef>
              <c:f>(Sheet1!$P$22,Sheet1!$V$22)</c:f>
              <c:numCache>
                <c:formatCode>General</c:formatCode>
                <c:ptCount val="2"/>
                <c:pt idx="0">
                  <c:v>18.535999999999998</c:v>
                </c:pt>
                <c:pt idx="1">
                  <c:v>17.3155555555555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CE-334F-8BB7-4381C35C388A}"/>
            </c:ext>
          </c:extLst>
        </c:ser>
        <c:ser>
          <c:idx val="1"/>
          <c:order val="1"/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P$25,Sheet1!$V$25)</c:f>
                <c:numCache>
                  <c:formatCode>General</c:formatCode>
                  <c:ptCount val="2"/>
                  <c:pt idx="0">
                    <c:v>1.0002208644983286</c:v>
                  </c:pt>
                  <c:pt idx="1">
                    <c:v>1.0589766548680668</c:v>
                  </c:pt>
                </c:numCache>
              </c:numRef>
            </c:plus>
            <c:minus>
              <c:numRef>
                <c:f>(Sheet1!$P$25,Sheet1!$V$25)</c:f>
                <c:numCache>
                  <c:formatCode>General</c:formatCode>
                  <c:ptCount val="2"/>
                  <c:pt idx="0">
                    <c:v>1.0002208644983286</c:v>
                  </c:pt>
                  <c:pt idx="1">
                    <c:v>1.05897665486806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M$1,Sheet1!$S$1)</c:f>
              <c:strCache>
                <c:ptCount val="2"/>
                <c:pt idx="0">
                  <c:v>7th leaf</c:v>
                </c:pt>
                <c:pt idx="1">
                  <c:v>9th leaf</c:v>
                </c:pt>
              </c:strCache>
            </c:strRef>
          </c:cat>
          <c:val>
            <c:numRef>
              <c:f>(Sheet1!$P$23,Sheet1!$V$23)</c:f>
              <c:numCache>
                <c:formatCode>General</c:formatCode>
                <c:ptCount val="2"/>
                <c:pt idx="0">
                  <c:v>21.338000000000001</c:v>
                </c:pt>
                <c:pt idx="1">
                  <c:v>20.985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5CE-334F-8BB7-4381C35C388A}"/>
            </c:ext>
          </c:extLst>
        </c:ser>
        <c:ser>
          <c:idx val="2"/>
          <c:order val="2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AB$25,Sheet1!$AB$26)</c:f>
                <c:numCache>
                  <c:formatCode>General</c:formatCode>
                  <c:ptCount val="2"/>
                  <c:pt idx="0">
                    <c:v>0.77678253785156071</c:v>
                  </c:pt>
                  <c:pt idx="1">
                    <c:v>0.67489595906002819</c:v>
                  </c:pt>
                </c:numCache>
              </c:numRef>
            </c:plus>
            <c:minus>
              <c:numRef>
                <c:f>(Sheet1!$AB$25,Sheet1!$AB$26)</c:f>
                <c:numCache>
                  <c:formatCode>General</c:formatCode>
                  <c:ptCount val="2"/>
                  <c:pt idx="0">
                    <c:v>0.77678253785156071</c:v>
                  </c:pt>
                  <c:pt idx="1">
                    <c:v>0.674895959060028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M$1,Sheet1!$S$1)</c:f>
              <c:strCache>
                <c:ptCount val="2"/>
                <c:pt idx="0">
                  <c:v>7th leaf</c:v>
                </c:pt>
                <c:pt idx="1">
                  <c:v>9th leaf</c:v>
                </c:pt>
              </c:strCache>
            </c:strRef>
          </c:cat>
          <c:val>
            <c:numRef>
              <c:f>(Sheet1!$AB$23,Sheet1!$AB$24)</c:f>
              <c:numCache>
                <c:formatCode>General</c:formatCode>
                <c:ptCount val="2"/>
                <c:pt idx="0">
                  <c:v>24.58</c:v>
                </c:pt>
                <c:pt idx="1">
                  <c:v>24.3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5CE-334F-8BB7-4381C35C38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80076416"/>
        <c:axId val="580071520"/>
      </c:barChart>
      <c:catAx>
        <c:axId val="580076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0071520"/>
        <c:crosses val="autoZero"/>
        <c:auto val="1"/>
        <c:lblAlgn val="ctr"/>
        <c:lblOffset val="100"/>
        <c:noMultiLvlLbl val="0"/>
      </c:catAx>
      <c:valAx>
        <c:axId val="5800715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dirty="0">
                    <a:solidFill>
                      <a:schemeClr val="tx1"/>
                    </a:solidFill>
                  </a:rPr>
                  <a:t>Leaf blade (m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0076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3762</cdr:x>
      <cdr:y>0.86605</cdr:y>
    </cdr:from>
    <cdr:to>
      <cdr:x>0.89034</cdr:x>
      <cdr:y>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763AF117-3931-A2F7-EECA-0BF976459112}"/>
            </a:ext>
          </a:extLst>
        </cdr:cNvPr>
        <cdr:cNvSpPr txBox="1"/>
      </cdr:nvSpPr>
      <cdr:spPr>
        <a:xfrm xmlns:a="http://schemas.openxmlformats.org/drawingml/2006/main">
          <a:off x="2202388" y="3669612"/>
          <a:ext cx="3605463" cy="5675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CA" sz="2200" dirty="0"/>
            <a:t>7</a:t>
          </a:r>
          <a:r>
            <a:rPr lang="en-CA" sz="2200" baseline="30000" dirty="0"/>
            <a:t>th</a:t>
          </a:r>
          <a:r>
            <a:rPr lang="en-CA" sz="2200" dirty="0"/>
            <a:t> leaf		9</a:t>
          </a:r>
          <a:r>
            <a:rPr lang="en-CA" sz="2200" baseline="30000" dirty="0"/>
            <a:t>th</a:t>
          </a:r>
          <a:r>
            <a:rPr lang="en-CA" sz="2200" dirty="0"/>
            <a:t> leaf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547135"/>
            <a:ext cx="10363200" cy="754581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1383941"/>
            <a:ext cx="9144000" cy="523289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620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021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153947"/>
            <a:ext cx="2628900" cy="1836783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153947"/>
            <a:ext cx="7734300" cy="1836783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825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000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5403489"/>
            <a:ext cx="10515600" cy="901583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4504620"/>
            <a:ext cx="10515600" cy="474121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323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769736"/>
            <a:ext cx="5181600" cy="137520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769736"/>
            <a:ext cx="5181600" cy="137520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6087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153952"/>
            <a:ext cx="10515600" cy="418933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5313176"/>
            <a:ext cx="5157787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917081"/>
            <a:ext cx="5157787" cy="1164483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5313176"/>
            <a:ext cx="5183188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917081"/>
            <a:ext cx="5183188" cy="1164483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465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027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270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120679"/>
            <a:ext cx="6172200" cy="1540268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285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120679"/>
            <a:ext cx="6172200" cy="1540268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5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153952"/>
            <a:ext cx="10515600" cy="4189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769736"/>
            <a:ext cx="10515600" cy="137520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133CF-B7A0-114F-9E16-A72C61FDA3E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0088720"/>
            <a:ext cx="41148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DFDEC-CF4D-5C4D-B4A8-BEE0C3C8E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204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29388060-32CE-D629-94EA-6204682663C8}"/>
              </a:ext>
            </a:extLst>
          </p:cNvPr>
          <p:cNvGrpSpPr/>
          <p:nvPr/>
        </p:nvGrpSpPr>
        <p:grpSpPr>
          <a:xfrm>
            <a:off x="288149" y="1001300"/>
            <a:ext cx="11068601" cy="11239822"/>
            <a:chOff x="288149" y="1001300"/>
            <a:chExt cx="11068601" cy="11239822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3A7B999-EE42-1371-E38C-81A2855B8AE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24200" y="4382015"/>
              <a:ext cx="2879751" cy="28800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D9297CAA-35D2-33B8-1959-A4C953B2CF6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58200" y="4381900"/>
              <a:ext cx="2879751" cy="288000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D83B2EC-0F8E-211F-4A19-5B3D3F93052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603000" y="4381900"/>
              <a:ext cx="2880000" cy="28800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7CA3755-BE8B-8D6A-592A-393F5577ECB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722779" y="1452849"/>
              <a:ext cx="2880000" cy="288025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EF07674C-031A-7218-E092-1075DAF1175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658200" y="1452849"/>
              <a:ext cx="2879751" cy="28800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B9D3D854-A856-21E7-65A7-CD7BDFB133D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603097" y="1452849"/>
              <a:ext cx="2880000" cy="288000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529581D-FF3A-69C7-514C-F2E16B97BFB2}"/>
                </a:ext>
              </a:extLst>
            </p:cNvPr>
            <p:cNvSpPr txBox="1"/>
            <p:nvPr/>
          </p:nvSpPr>
          <p:spPr>
            <a:xfrm>
              <a:off x="1660195" y="1394089"/>
              <a:ext cx="55485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800" b="1" dirty="0">
                  <a:solidFill>
                    <a:schemeClr val="bg1"/>
                  </a:solidFill>
                </a:rPr>
                <a:t>A</a:t>
              </a:r>
              <a:endParaRPr lang="en-CA" b="1" dirty="0">
                <a:solidFill>
                  <a:schemeClr val="bg1"/>
                </a:solidFill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44A3E40-50C9-EB05-B556-09F107B69CCC}"/>
                </a:ext>
              </a:extLst>
            </p:cNvPr>
            <p:cNvSpPr txBox="1"/>
            <p:nvPr/>
          </p:nvSpPr>
          <p:spPr>
            <a:xfrm>
              <a:off x="4593895" y="1394089"/>
              <a:ext cx="55485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800" b="1" dirty="0">
                  <a:solidFill>
                    <a:schemeClr val="bg1"/>
                  </a:solidFill>
                </a:rPr>
                <a:t>B</a:t>
              </a:r>
              <a:endParaRPr lang="en-CA" b="1" dirty="0">
                <a:solidFill>
                  <a:schemeClr val="bg1"/>
                </a:solidFill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C4EF15B-460A-1FC9-6D44-34633A9B255B}"/>
                </a:ext>
              </a:extLst>
            </p:cNvPr>
            <p:cNvSpPr txBox="1"/>
            <p:nvPr/>
          </p:nvSpPr>
          <p:spPr>
            <a:xfrm>
              <a:off x="7540295" y="1394089"/>
              <a:ext cx="55485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800" b="1" dirty="0">
                  <a:solidFill>
                    <a:schemeClr val="bg1"/>
                  </a:solidFill>
                </a:rPr>
                <a:t>C</a:t>
              </a:r>
              <a:endParaRPr lang="en-CA" b="1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ADD44F6-182C-D605-DB1E-6C33CABE193C}"/>
                </a:ext>
              </a:extLst>
            </p:cNvPr>
            <p:cNvSpPr txBox="1"/>
            <p:nvPr/>
          </p:nvSpPr>
          <p:spPr>
            <a:xfrm>
              <a:off x="1660195" y="4315089"/>
              <a:ext cx="55485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800" b="1" dirty="0">
                  <a:solidFill>
                    <a:schemeClr val="bg1"/>
                  </a:solidFill>
                </a:rPr>
                <a:t>D</a:t>
              </a:r>
              <a:endParaRPr lang="en-CA" b="1" dirty="0">
                <a:solidFill>
                  <a:schemeClr val="bg1"/>
                </a:solidFill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36082EC-B8BC-0273-AB60-EB9A7D9B499B}"/>
                </a:ext>
              </a:extLst>
            </p:cNvPr>
            <p:cNvSpPr txBox="1"/>
            <p:nvPr/>
          </p:nvSpPr>
          <p:spPr>
            <a:xfrm>
              <a:off x="4593895" y="4315089"/>
              <a:ext cx="55485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800" b="1" dirty="0">
                  <a:solidFill>
                    <a:schemeClr val="bg1"/>
                  </a:solidFill>
                </a:rPr>
                <a:t>E</a:t>
              </a:r>
              <a:endParaRPr lang="en-CA" b="1" dirty="0">
                <a:solidFill>
                  <a:schemeClr val="bg1"/>
                </a:solidFill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A95B7D1-FD2A-00C7-EF59-4C680CA47C1A}"/>
                </a:ext>
              </a:extLst>
            </p:cNvPr>
            <p:cNvSpPr txBox="1"/>
            <p:nvPr/>
          </p:nvSpPr>
          <p:spPr>
            <a:xfrm>
              <a:off x="7540295" y="4315089"/>
              <a:ext cx="55485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800" b="1" dirty="0">
                  <a:solidFill>
                    <a:schemeClr val="bg1"/>
                  </a:solidFill>
                </a:rPr>
                <a:t>F</a:t>
              </a:r>
              <a:endParaRPr lang="en-CA" b="1" dirty="0">
                <a:solidFill>
                  <a:schemeClr val="bg1"/>
                </a:solidFill>
              </a:endParaRPr>
            </a:p>
          </p:txBody>
        </p:sp>
        <p:graphicFrame>
          <p:nvGraphicFramePr>
            <p:cNvPr id="22" name="Chart 21">
              <a:extLst>
                <a:ext uri="{FF2B5EF4-FFF2-40B4-BE49-F238E27FC236}">
                  <a16:creationId xmlns:a16="http://schemas.microsoft.com/office/drawing/2014/main" id="{AC38F29E-8CA3-E38E-4D83-8D664F807D2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96323724"/>
                </p:ext>
              </p:extLst>
            </p:nvPr>
          </p:nvGraphicFramePr>
          <p:xfrm>
            <a:off x="288149" y="7667703"/>
            <a:ext cx="6523200" cy="4237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23" name="Chart 22">
              <a:extLst>
                <a:ext uri="{FF2B5EF4-FFF2-40B4-BE49-F238E27FC236}">
                  <a16:creationId xmlns:a16="http://schemas.microsoft.com/office/drawing/2014/main" id="{7040C308-851A-DCA0-B7B0-43A49C41672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5350857"/>
                </p:ext>
              </p:extLst>
            </p:nvPr>
          </p:nvGraphicFramePr>
          <p:xfrm>
            <a:off x="4833550" y="7667703"/>
            <a:ext cx="6523200" cy="4237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B397564-39F2-3A7D-9AA3-9DE7D7406C2E}"/>
                </a:ext>
              </a:extLst>
            </p:cNvPr>
            <p:cNvSpPr txBox="1"/>
            <p:nvPr/>
          </p:nvSpPr>
          <p:spPr>
            <a:xfrm>
              <a:off x="3157995" y="7658321"/>
              <a:ext cx="485196" cy="461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2400" dirty="0"/>
                <a:t>b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74914F2-245C-61D5-F97E-9B07DF9E62C0}"/>
                </a:ext>
              </a:extLst>
            </p:cNvPr>
            <p:cNvSpPr txBox="1"/>
            <p:nvPr/>
          </p:nvSpPr>
          <p:spPr>
            <a:xfrm>
              <a:off x="4985852" y="7882902"/>
              <a:ext cx="485196" cy="461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2400" dirty="0"/>
                <a:t>b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4A684CE-6582-5C96-D9AA-68B9FF396B41}"/>
                </a:ext>
              </a:extLst>
            </p:cNvPr>
            <p:cNvSpPr txBox="1"/>
            <p:nvPr/>
          </p:nvSpPr>
          <p:spPr>
            <a:xfrm>
              <a:off x="7746111" y="8278841"/>
              <a:ext cx="485196" cy="461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2400" dirty="0"/>
                <a:t>b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CE09E23-ED97-3A2B-5B43-C9AC085432C2}"/>
                </a:ext>
              </a:extLst>
            </p:cNvPr>
            <p:cNvSpPr txBox="1"/>
            <p:nvPr/>
          </p:nvSpPr>
          <p:spPr>
            <a:xfrm>
              <a:off x="9648981" y="8301881"/>
              <a:ext cx="485196" cy="461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2400" dirty="0"/>
                <a:t>b</a:t>
              </a:r>
            </a:p>
          </p:txBody>
        </p:sp>
        <p:sp>
          <p:nvSpPr>
            <p:cNvPr id="6" name="TextBox 1">
              <a:extLst>
                <a:ext uri="{FF2B5EF4-FFF2-40B4-BE49-F238E27FC236}">
                  <a16:creationId xmlns:a16="http://schemas.microsoft.com/office/drawing/2014/main" id="{A40DD904-911C-D230-D55D-F146419DEAE9}"/>
                </a:ext>
              </a:extLst>
            </p:cNvPr>
            <p:cNvSpPr txBox="1"/>
            <p:nvPr/>
          </p:nvSpPr>
          <p:spPr>
            <a:xfrm>
              <a:off x="7136201" y="11337315"/>
              <a:ext cx="3605463" cy="567588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CA" sz="2200" dirty="0"/>
                <a:t>7</a:t>
              </a:r>
              <a:r>
                <a:rPr lang="en-CA" sz="2200" baseline="30000" dirty="0"/>
                <a:t>th</a:t>
              </a:r>
              <a:r>
                <a:rPr lang="en-CA" sz="2200" dirty="0"/>
                <a:t> leaf			9</a:t>
              </a:r>
              <a:r>
                <a:rPr lang="en-CA" sz="2200" baseline="30000" dirty="0"/>
                <a:t>th</a:t>
              </a:r>
              <a:r>
                <a:rPr lang="en-CA" sz="2200" dirty="0"/>
                <a:t> leaf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6FF3CA1-F286-293F-8F3A-ED467987DC14}"/>
                </a:ext>
              </a:extLst>
            </p:cNvPr>
            <p:cNvSpPr txBox="1"/>
            <p:nvPr/>
          </p:nvSpPr>
          <p:spPr>
            <a:xfrm>
              <a:off x="3638593" y="7713502"/>
              <a:ext cx="34657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400" dirty="0"/>
                <a:t>b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2D7D615-AEA8-7D30-0CE8-D2F093AFFFC4}"/>
                </a:ext>
              </a:extLst>
            </p:cNvPr>
            <p:cNvSpPr txBox="1"/>
            <p:nvPr/>
          </p:nvSpPr>
          <p:spPr>
            <a:xfrm>
              <a:off x="5456191" y="7827615"/>
              <a:ext cx="34657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b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7DEA09F-EEDF-EC88-8FCA-D56EF0CE3F76}"/>
                </a:ext>
              </a:extLst>
            </p:cNvPr>
            <p:cNvSpPr txBox="1"/>
            <p:nvPr/>
          </p:nvSpPr>
          <p:spPr>
            <a:xfrm>
              <a:off x="8258130" y="7937313"/>
              <a:ext cx="31451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400" dirty="0"/>
                <a:t>c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67BFB98-A7E2-2022-580A-20DC2478794D}"/>
                </a:ext>
              </a:extLst>
            </p:cNvPr>
            <p:cNvSpPr txBox="1"/>
            <p:nvPr/>
          </p:nvSpPr>
          <p:spPr>
            <a:xfrm>
              <a:off x="10148749" y="7965513"/>
              <a:ext cx="31451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400" dirty="0"/>
                <a:t>c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2E7D844-C3ED-C6A8-B9CC-8DFCB622DAF3}"/>
                </a:ext>
              </a:extLst>
            </p:cNvPr>
            <p:cNvSpPr txBox="1"/>
            <p:nvPr/>
          </p:nvSpPr>
          <p:spPr>
            <a:xfrm>
              <a:off x="1659600" y="7423360"/>
              <a:ext cx="55485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800" b="1" dirty="0"/>
                <a:t>G</a:t>
              </a:r>
              <a:endParaRPr lang="en-CA" b="1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BD6A575-27AC-4664-89DE-C64F744828CE}"/>
                </a:ext>
              </a:extLst>
            </p:cNvPr>
            <p:cNvSpPr txBox="1"/>
            <p:nvPr/>
          </p:nvSpPr>
          <p:spPr>
            <a:xfrm>
              <a:off x="6182002" y="7422230"/>
              <a:ext cx="55485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800" b="1" dirty="0"/>
                <a:t>H</a:t>
              </a:r>
              <a:endParaRPr lang="en-CA" b="1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F1E67AD-1943-35BA-5E59-C575BADD7332}"/>
                </a:ext>
              </a:extLst>
            </p:cNvPr>
            <p:cNvSpPr txBox="1"/>
            <p:nvPr/>
          </p:nvSpPr>
          <p:spPr>
            <a:xfrm>
              <a:off x="2764758" y="8260420"/>
              <a:ext cx="485196" cy="461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F1D4C71-4230-3476-0AB4-05D5991B741E}"/>
                </a:ext>
              </a:extLst>
            </p:cNvPr>
            <p:cNvSpPr txBox="1"/>
            <p:nvPr/>
          </p:nvSpPr>
          <p:spPr>
            <a:xfrm>
              <a:off x="4583069" y="8562681"/>
              <a:ext cx="485196" cy="461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97A4398-70E0-E210-A7AC-E02CE31E27D5}"/>
                </a:ext>
              </a:extLst>
            </p:cNvPr>
            <p:cNvSpPr txBox="1"/>
            <p:nvPr/>
          </p:nvSpPr>
          <p:spPr>
            <a:xfrm>
              <a:off x="7332177" y="8599289"/>
              <a:ext cx="485196" cy="461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748972A-7E26-881F-FE27-CC4245413BD2}"/>
                </a:ext>
              </a:extLst>
            </p:cNvPr>
            <p:cNvSpPr txBox="1"/>
            <p:nvPr/>
          </p:nvSpPr>
          <p:spPr>
            <a:xfrm>
              <a:off x="9226674" y="8726289"/>
              <a:ext cx="485196" cy="461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2400" dirty="0"/>
                <a:t>a</a:t>
              </a:r>
            </a:p>
          </p:txBody>
        </p: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EF76B4F9-226E-5587-4DA4-7BD0904AFED5}"/>
                </a:ext>
              </a:extLst>
            </p:cNvPr>
            <p:cNvGrpSpPr/>
            <p:nvPr/>
          </p:nvGrpSpPr>
          <p:grpSpPr>
            <a:xfrm>
              <a:off x="3819083" y="11931939"/>
              <a:ext cx="4730428" cy="309183"/>
              <a:chOff x="6644332" y="943200"/>
              <a:chExt cx="4730428" cy="309183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586A7D5C-E7F9-8DDD-7CF5-F20FDF703FAC}"/>
                  </a:ext>
                </a:extLst>
              </p:cNvPr>
              <p:cNvSpPr/>
              <p:nvPr/>
            </p:nvSpPr>
            <p:spPr>
              <a:xfrm>
                <a:off x="6644332" y="1006209"/>
                <a:ext cx="174171" cy="17373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CA608001-280D-4AFF-E7CE-381BE4C52FD7}"/>
                  </a:ext>
                </a:extLst>
              </p:cNvPr>
              <p:cNvSpPr/>
              <p:nvPr/>
            </p:nvSpPr>
            <p:spPr>
              <a:xfrm>
                <a:off x="7877373" y="1006209"/>
                <a:ext cx="174171" cy="173736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6D82070F-091B-989E-9D8E-E2AE04644662}"/>
                  </a:ext>
                </a:extLst>
              </p:cNvPr>
              <p:cNvSpPr/>
              <p:nvPr/>
            </p:nvSpPr>
            <p:spPr>
              <a:xfrm>
                <a:off x="9668888" y="1008000"/>
                <a:ext cx="174171" cy="173736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04FC6986-0CA5-B500-9662-C79F8B84B435}"/>
                  </a:ext>
                </a:extLst>
              </p:cNvPr>
              <p:cNvSpPr txBox="1"/>
              <p:nvPr/>
            </p:nvSpPr>
            <p:spPr>
              <a:xfrm>
                <a:off x="6825840" y="943200"/>
                <a:ext cx="9653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400" dirty="0"/>
                  <a:t>Weed-free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FA45D1CC-9069-5215-252B-E0C84D9B12C8}"/>
                  </a:ext>
                </a:extLst>
              </p:cNvPr>
              <p:cNvSpPr txBox="1"/>
              <p:nvPr/>
            </p:nvSpPr>
            <p:spPr>
              <a:xfrm>
                <a:off x="8051664" y="944605"/>
                <a:ext cx="160183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400" dirty="0"/>
                  <a:t>Biological low R:FR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972160AC-01D5-77D9-85B9-FD30C037160C}"/>
                  </a:ext>
                </a:extLst>
              </p:cNvPr>
              <p:cNvSpPr txBox="1"/>
              <p:nvPr/>
            </p:nvSpPr>
            <p:spPr>
              <a:xfrm>
                <a:off x="9847119" y="944606"/>
                <a:ext cx="15276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400" dirty="0"/>
                  <a:t>Artificial low R:FR</a:t>
                </a:r>
              </a:p>
            </p:txBody>
          </p:sp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08299B2-A2E0-46EA-4AC4-B4F0AC8C7C70}"/>
                </a:ext>
              </a:extLst>
            </p:cNvPr>
            <p:cNvSpPr txBox="1"/>
            <p:nvPr/>
          </p:nvSpPr>
          <p:spPr>
            <a:xfrm>
              <a:off x="2455755" y="1001300"/>
              <a:ext cx="1455335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200" dirty="0"/>
                <a:t>Weed-free</a:t>
              </a:r>
              <a:r>
                <a:rPr lang="en-US" dirty="0"/>
                <a:t> 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7427D18-070E-9D53-89CC-4CB47E4D883F}"/>
                </a:ext>
              </a:extLst>
            </p:cNvPr>
            <p:cNvSpPr txBox="1"/>
            <p:nvPr/>
          </p:nvSpPr>
          <p:spPr>
            <a:xfrm>
              <a:off x="4906855" y="1001300"/>
              <a:ext cx="239655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200" dirty="0"/>
                <a:t>Biological low R:FR 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771EC04-B900-6EC5-7A08-4DD454A646B2}"/>
                </a:ext>
              </a:extLst>
            </p:cNvPr>
            <p:cNvSpPr txBox="1"/>
            <p:nvPr/>
          </p:nvSpPr>
          <p:spPr>
            <a:xfrm>
              <a:off x="7929455" y="1001300"/>
              <a:ext cx="225625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200" dirty="0"/>
                <a:t>Artificial low R:FR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83392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034a106e-6316-442c-ad35-738afd673d2b}" enabled="1" method="Standard" siteId="{cddc1229-ac2a-4b97-b78a-0e5cacb5865c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80</TotalTime>
  <Words>64</Words>
  <Application>Microsoft Macintosh PowerPoint</Application>
  <PresentationFormat>Custom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an Amirsadeghi</dc:creator>
  <cp:lastModifiedBy>Sasan Amirsadeghi</cp:lastModifiedBy>
  <cp:revision>20</cp:revision>
  <dcterms:created xsi:type="dcterms:W3CDTF">2024-03-04T15:49:30Z</dcterms:created>
  <dcterms:modified xsi:type="dcterms:W3CDTF">2024-07-18T15:12:59Z</dcterms:modified>
</cp:coreProperties>
</file>